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6858000" cy="9144000" type="screen4x3"/>
  <p:notesSz cx="7099300" cy="10234613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6600"/>
    <a:srgbClr val="FF33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howGuides="1">
      <p:cViewPr>
        <p:scale>
          <a:sx n="100" d="100"/>
          <a:sy n="100" d="100"/>
        </p:scale>
        <p:origin x="1674" y="24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76575" cy="51117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4021138" y="0"/>
            <a:ext cx="3076575" cy="51117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1156DAB-FEEA-48A3-AE20-D09DF20204B7}" type="datetimeFigureOut">
              <a:rPr lang="en-GB" smtClean="0"/>
              <a:pPr/>
              <a:t>15/09/2015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11375" y="768350"/>
            <a:ext cx="2876550" cy="3836988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9613" y="4860925"/>
            <a:ext cx="5680075" cy="4605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721850"/>
            <a:ext cx="3076575" cy="51117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4021138" y="9721850"/>
            <a:ext cx="3076575" cy="51117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1C48C05-6B05-42FF-8CB0-D57FE80B1078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816071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1C48C05-6B05-42FF-8CB0-D57FE80B1078}" type="slidenum">
              <a:rPr lang="en-GB" smtClean="0"/>
              <a:pPr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7596221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F0575A-A5CE-4A49-9C45-05E4A2E3FFA2}" type="datetimeFigureOut">
              <a:rPr lang="en-GB" smtClean="0"/>
              <a:pPr/>
              <a:t>15/09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E41373-0B98-463B-A7A9-7C4D06180546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F0575A-A5CE-4A49-9C45-05E4A2E3FFA2}" type="datetimeFigureOut">
              <a:rPr lang="en-GB" smtClean="0"/>
              <a:pPr/>
              <a:t>15/09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E41373-0B98-463B-A7A9-7C4D06180546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F0575A-A5CE-4A49-9C45-05E4A2E3FFA2}" type="datetimeFigureOut">
              <a:rPr lang="en-GB" smtClean="0"/>
              <a:pPr/>
              <a:t>15/09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E41373-0B98-463B-A7A9-7C4D06180546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F0575A-A5CE-4A49-9C45-05E4A2E3FFA2}" type="datetimeFigureOut">
              <a:rPr lang="en-GB" smtClean="0"/>
              <a:pPr/>
              <a:t>15/09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E41373-0B98-463B-A7A9-7C4D06180546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F0575A-A5CE-4A49-9C45-05E4A2E3FFA2}" type="datetimeFigureOut">
              <a:rPr lang="en-GB" smtClean="0"/>
              <a:pPr/>
              <a:t>15/09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E41373-0B98-463B-A7A9-7C4D06180546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F0575A-A5CE-4A49-9C45-05E4A2E3FFA2}" type="datetimeFigureOut">
              <a:rPr lang="en-GB" smtClean="0"/>
              <a:pPr/>
              <a:t>15/09/201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E41373-0B98-463B-A7A9-7C4D06180546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F0575A-A5CE-4A49-9C45-05E4A2E3FFA2}" type="datetimeFigureOut">
              <a:rPr lang="en-GB" smtClean="0"/>
              <a:pPr/>
              <a:t>15/09/2015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E41373-0B98-463B-A7A9-7C4D06180546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F0575A-A5CE-4A49-9C45-05E4A2E3FFA2}" type="datetimeFigureOut">
              <a:rPr lang="en-GB" smtClean="0"/>
              <a:pPr/>
              <a:t>15/09/2015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E41373-0B98-463B-A7A9-7C4D06180546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F0575A-A5CE-4A49-9C45-05E4A2E3FFA2}" type="datetimeFigureOut">
              <a:rPr lang="en-GB" smtClean="0"/>
              <a:pPr/>
              <a:t>15/09/2015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E41373-0B98-463B-A7A9-7C4D06180546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F0575A-A5CE-4A49-9C45-05E4A2E3FFA2}" type="datetimeFigureOut">
              <a:rPr lang="en-GB" smtClean="0"/>
              <a:pPr/>
              <a:t>15/09/201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E41373-0B98-463B-A7A9-7C4D06180546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F0575A-A5CE-4A49-9C45-05E4A2E3FFA2}" type="datetimeFigureOut">
              <a:rPr lang="en-GB" smtClean="0"/>
              <a:pPr/>
              <a:t>15/09/201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E41373-0B98-463B-A7A9-7C4D06180546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0F0575A-A5CE-4A49-9C45-05E4A2E3FFA2}" type="datetimeFigureOut">
              <a:rPr lang="en-GB" smtClean="0"/>
              <a:pPr/>
              <a:t>15/09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1E41373-0B98-463B-A7A9-7C4D06180546}" type="slidenum">
              <a:rPr lang="en-GB" smtClean="0"/>
              <a:pPr/>
              <a:t>‹#›</a:t>
            </a:fld>
            <a:endParaRPr lang="en-GB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1359" y="4944470"/>
            <a:ext cx="2987325" cy="1788034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32469" y="4981188"/>
            <a:ext cx="2987325" cy="1751315"/>
          </a:xfrm>
          <a:prstGeom prst="rect">
            <a:avLst/>
          </a:prstGeom>
        </p:spPr>
      </p:pic>
      <p:sp>
        <p:nvSpPr>
          <p:cNvPr id="10" name="TextBox 9"/>
          <p:cNvSpPr txBox="1"/>
          <p:nvPr/>
        </p:nvSpPr>
        <p:spPr>
          <a:xfrm>
            <a:off x="4936274" y="6823385"/>
            <a:ext cx="72968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n-GB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-tubulin</a:t>
            </a:r>
            <a:endParaRPr lang="en-GB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1759029" y="6861518"/>
            <a:ext cx="58862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n-GB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-H2A</a:t>
            </a:r>
            <a:endParaRPr lang="en-GB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8" name="Picture 7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958282" y="1461246"/>
            <a:ext cx="2239200" cy="1926000"/>
          </a:xfrm>
          <a:prstGeom prst="rect">
            <a:avLst/>
          </a:prstGeom>
        </p:spPr>
      </p:pic>
      <p:pic>
        <p:nvPicPr>
          <p:cNvPr id="9" name="Picture 8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86832" y="1403646"/>
            <a:ext cx="2235600" cy="1983600"/>
          </a:xfrm>
          <a:prstGeom prst="rect">
            <a:avLst/>
          </a:prstGeom>
        </p:spPr>
      </p:pic>
      <p:sp>
        <p:nvSpPr>
          <p:cNvPr id="50" name="TextBox 49"/>
          <p:cNvSpPr txBox="1"/>
          <p:nvPr/>
        </p:nvSpPr>
        <p:spPr>
          <a:xfrm>
            <a:off x="4802923" y="3388847"/>
            <a:ext cx="72968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n-GB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-tubulin</a:t>
            </a:r>
            <a:endParaRPr lang="en-GB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1687403" y="3477780"/>
            <a:ext cx="49404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n-GB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-H3</a:t>
            </a:r>
            <a:endParaRPr lang="en-GB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TextBox 32"/>
          <p:cNvSpPr txBox="1"/>
          <p:nvPr/>
        </p:nvSpPr>
        <p:spPr>
          <a:xfrm rot="16200000">
            <a:off x="1991033" y="1108149"/>
            <a:ext cx="32573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lang="en-US" sz="105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TextBox 33"/>
          <p:cNvSpPr txBox="1"/>
          <p:nvPr/>
        </p:nvSpPr>
        <p:spPr>
          <a:xfrm rot="16200000">
            <a:off x="971920" y="1108149"/>
            <a:ext cx="32573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lang="en-US" sz="105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TextBox 34"/>
          <p:cNvSpPr txBox="1"/>
          <p:nvPr/>
        </p:nvSpPr>
        <p:spPr>
          <a:xfrm rot="16200000">
            <a:off x="1452782" y="1108149"/>
            <a:ext cx="32573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lang="en-US" sz="105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TextBox 35"/>
          <p:cNvSpPr txBox="1"/>
          <p:nvPr/>
        </p:nvSpPr>
        <p:spPr>
          <a:xfrm rot="16200000">
            <a:off x="2251155" y="1108149"/>
            <a:ext cx="32573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lang="en-US" sz="105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TextBox 40"/>
          <p:cNvSpPr txBox="1"/>
          <p:nvPr/>
        </p:nvSpPr>
        <p:spPr>
          <a:xfrm rot="16200000">
            <a:off x="5220021" y="1108149"/>
            <a:ext cx="32573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lang="en-US" sz="105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TextBox 41"/>
          <p:cNvSpPr txBox="1"/>
          <p:nvPr/>
        </p:nvSpPr>
        <p:spPr>
          <a:xfrm rot="16200000">
            <a:off x="4211857" y="1108149"/>
            <a:ext cx="32573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lang="en-US" sz="105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TextBox 42"/>
          <p:cNvSpPr txBox="1"/>
          <p:nvPr/>
        </p:nvSpPr>
        <p:spPr>
          <a:xfrm rot="16200000">
            <a:off x="4692719" y="1108149"/>
            <a:ext cx="32573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lang="en-US" sz="105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TextBox 43"/>
          <p:cNvSpPr txBox="1"/>
          <p:nvPr/>
        </p:nvSpPr>
        <p:spPr>
          <a:xfrm rot="16200000">
            <a:off x="5458245" y="1108149"/>
            <a:ext cx="32573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lang="en-US" sz="105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TextBox 28"/>
          <p:cNvSpPr txBox="1"/>
          <p:nvPr/>
        </p:nvSpPr>
        <p:spPr>
          <a:xfrm rot="16200000">
            <a:off x="685706" y="974298"/>
            <a:ext cx="58541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i="1" dirty="0" smtClean="0">
                <a:latin typeface="Arial" panose="020B0604020202020204" pitchFamily="34" charset="0"/>
                <a:cs typeface="Arial" panose="020B0604020202020204" pitchFamily="34" charset="0"/>
              </a:rPr>
              <a:t>abo1</a:t>
            </a:r>
            <a:r>
              <a:rPr lang="en-US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∆</a:t>
            </a:r>
            <a:endParaRPr 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TextBox 44"/>
          <p:cNvSpPr txBox="1"/>
          <p:nvPr/>
        </p:nvSpPr>
        <p:spPr>
          <a:xfrm rot="16200000">
            <a:off x="1131105" y="974298"/>
            <a:ext cx="58541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i="1" dirty="0" smtClean="0">
                <a:latin typeface="Arial" panose="020B0604020202020204" pitchFamily="34" charset="0"/>
                <a:cs typeface="Arial" panose="020B0604020202020204" pitchFamily="34" charset="0"/>
              </a:rPr>
              <a:t>abo1</a:t>
            </a:r>
            <a:r>
              <a:rPr lang="en-US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∆</a:t>
            </a:r>
            <a:endParaRPr 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TextBox 45"/>
          <p:cNvSpPr txBox="1"/>
          <p:nvPr/>
        </p:nvSpPr>
        <p:spPr>
          <a:xfrm rot="16200000">
            <a:off x="1644350" y="974298"/>
            <a:ext cx="58541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i="1" dirty="0" smtClean="0">
                <a:latin typeface="Arial" panose="020B0604020202020204" pitchFamily="34" charset="0"/>
                <a:cs typeface="Arial" panose="020B0604020202020204" pitchFamily="34" charset="0"/>
              </a:rPr>
              <a:t>abo1</a:t>
            </a:r>
            <a:r>
              <a:rPr lang="en-US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∆</a:t>
            </a:r>
            <a:endParaRPr 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TextBox 46"/>
          <p:cNvSpPr txBox="1"/>
          <p:nvPr/>
        </p:nvSpPr>
        <p:spPr>
          <a:xfrm rot="16200000">
            <a:off x="2313369" y="974298"/>
            <a:ext cx="58541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i="1" dirty="0" smtClean="0">
                <a:latin typeface="Arial" panose="020B0604020202020204" pitchFamily="34" charset="0"/>
                <a:cs typeface="Arial" panose="020B0604020202020204" pitchFamily="34" charset="0"/>
              </a:rPr>
              <a:t>abo1</a:t>
            </a:r>
            <a:r>
              <a:rPr lang="en-US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∆</a:t>
            </a:r>
            <a:endParaRPr 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TextBox 50"/>
          <p:cNvSpPr txBox="1"/>
          <p:nvPr/>
        </p:nvSpPr>
        <p:spPr>
          <a:xfrm rot="16200000">
            <a:off x="3824383" y="974298"/>
            <a:ext cx="58541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i="1" dirty="0" smtClean="0">
                <a:latin typeface="Arial" panose="020B0604020202020204" pitchFamily="34" charset="0"/>
                <a:cs typeface="Arial" panose="020B0604020202020204" pitchFamily="34" charset="0"/>
              </a:rPr>
              <a:t>abo1</a:t>
            </a:r>
            <a:r>
              <a:rPr lang="en-US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∆</a:t>
            </a:r>
            <a:endParaRPr 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TextBox 51"/>
          <p:cNvSpPr txBox="1"/>
          <p:nvPr/>
        </p:nvSpPr>
        <p:spPr>
          <a:xfrm rot="16200000">
            <a:off x="4369797" y="974298"/>
            <a:ext cx="58541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i="1" dirty="0" smtClean="0">
                <a:latin typeface="Arial" panose="020B0604020202020204" pitchFamily="34" charset="0"/>
                <a:cs typeface="Arial" panose="020B0604020202020204" pitchFamily="34" charset="0"/>
              </a:rPr>
              <a:t>abo1</a:t>
            </a:r>
            <a:r>
              <a:rPr lang="en-US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∆</a:t>
            </a:r>
            <a:endParaRPr 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TextBox 52"/>
          <p:cNvSpPr txBox="1"/>
          <p:nvPr/>
        </p:nvSpPr>
        <p:spPr>
          <a:xfrm rot="16200000">
            <a:off x="4892568" y="974298"/>
            <a:ext cx="58541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i="1" dirty="0" smtClean="0">
                <a:latin typeface="Arial" panose="020B0604020202020204" pitchFamily="34" charset="0"/>
                <a:cs typeface="Arial" panose="020B0604020202020204" pitchFamily="34" charset="0"/>
              </a:rPr>
              <a:t>abo1</a:t>
            </a:r>
            <a:r>
              <a:rPr lang="en-US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∆</a:t>
            </a:r>
            <a:endParaRPr 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TextBox 53"/>
          <p:cNvSpPr txBox="1"/>
          <p:nvPr/>
        </p:nvSpPr>
        <p:spPr>
          <a:xfrm rot="16200000">
            <a:off x="5504436" y="974298"/>
            <a:ext cx="58541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i="1" dirty="0" smtClean="0">
                <a:latin typeface="Arial" panose="020B0604020202020204" pitchFamily="34" charset="0"/>
                <a:cs typeface="Arial" panose="020B0604020202020204" pitchFamily="34" charset="0"/>
              </a:rPr>
              <a:t>abo1</a:t>
            </a:r>
            <a:r>
              <a:rPr lang="en-US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∆</a:t>
            </a:r>
            <a:endParaRPr 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5" name="Straight Connector 54"/>
          <p:cNvCxnSpPr/>
          <p:nvPr/>
        </p:nvCxnSpPr>
        <p:spPr>
          <a:xfrm>
            <a:off x="868875" y="1362260"/>
            <a:ext cx="40441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7" name="Straight Connector 56"/>
          <p:cNvCxnSpPr/>
          <p:nvPr/>
        </p:nvCxnSpPr>
        <p:spPr>
          <a:xfrm>
            <a:off x="1311574" y="1362260"/>
            <a:ext cx="40441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8" name="Straight Connector 57"/>
          <p:cNvCxnSpPr/>
          <p:nvPr/>
        </p:nvCxnSpPr>
        <p:spPr>
          <a:xfrm>
            <a:off x="1860557" y="1362260"/>
            <a:ext cx="40441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9" name="Straight Connector 58"/>
          <p:cNvCxnSpPr/>
          <p:nvPr/>
        </p:nvCxnSpPr>
        <p:spPr>
          <a:xfrm>
            <a:off x="2303256" y="1362260"/>
            <a:ext cx="40441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0" name="Straight Connector 59"/>
          <p:cNvCxnSpPr/>
          <p:nvPr/>
        </p:nvCxnSpPr>
        <p:spPr>
          <a:xfrm>
            <a:off x="4098229" y="1403831"/>
            <a:ext cx="40441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1" name="Straight Connector 60"/>
          <p:cNvCxnSpPr/>
          <p:nvPr/>
        </p:nvCxnSpPr>
        <p:spPr>
          <a:xfrm>
            <a:off x="4540928" y="1403831"/>
            <a:ext cx="40441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2" name="Straight Connector 61"/>
          <p:cNvCxnSpPr/>
          <p:nvPr/>
        </p:nvCxnSpPr>
        <p:spPr>
          <a:xfrm>
            <a:off x="5089911" y="1403831"/>
            <a:ext cx="40441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3" name="Straight Connector 62"/>
          <p:cNvCxnSpPr/>
          <p:nvPr/>
        </p:nvCxnSpPr>
        <p:spPr>
          <a:xfrm>
            <a:off x="5532610" y="1403831"/>
            <a:ext cx="40441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4" name="TextBox 63"/>
          <p:cNvSpPr txBox="1"/>
          <p:nvPr/>
        </p:nvSpPr>
        <p:spPr>
          <a:xfrm>
            <a:off x="6174709" y="1781175"/>
            <a:ext cx="61747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~55 </a:t>
            </a:r>
            <a:r>
              <a:rPr lang="en-GB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5" name="TextBox 64"/>
          <p:cNvSpPr txBox="1"/>
          <p:nvPr/>
        </p:nvSpPr>
        <p:spPr>
          <a:xfrm>
            <a:off x="2897390" y="1781175"/>
            <a:ext cx="61747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~55 </a:t>
            </a:r>
            <a:r>
              <a:rPr lang="en-GB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" name="TextBox 65"/>
          <p:cNvSpPr txBox="1"/>
          <p:nvPr/>
        </p:nvSpPr>
        <p:spPr>
          <a:xfrm>
            <a:off x="6174709" y="2886600"/>
            <a:ext cx="61747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~15 </a:t>
            </a:r>
            <a:r>
              <a:rPr lang="en-GB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7" name="TextBox 66"/>
          <p:cNvSpPr txBox="1"/>
          <p:nvPr/>
        </p:nvSpPr>
        <p:spPr>
          <a:xfrm>
            <a:off x="2897390" y="2886600"/>
            <a:ext cx="61747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~15 </a:t>
            </a:r>
            <a:r>
              <a:rPr lang="en-GB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00" name="Group 99"/>
          <p:cNvGrpSpPr/>
          <p:nvPr/>
        </p:nvGrpSpPr>
        <p:grpSpPr>
          <a:xfrm>
            <a:off x="669775" y="4338620"/>
            <a:ext cx="2684770" cy="585418"/>
            <a:chOff x="479275" y="4411772"/>
            <a:chExt cx="2684770" cy="585418"/>
          </a:xfrm>
        </p:grpSpPr>
        <p:sp>
          <p:nvSpPr>
            <p:cNvPr id="68" name="TextBox 67"/>
            <p:cNvSpPr txBox="1"/>
            <p:nvPr/>
          </p:nvSpPr>
          <p:spPr>
            <a:xfrm rot="16200000">
              <a:off x="1956913" y="4703520"/>
              <a:ext cx="32573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50" i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wt</a:t>
              </a:r>
              <a:endParaRPr lang="en-US" sz="1050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9" name="TextBox 68"/>
            <p:cNvSpPr txBox="1"/>
            <p:nvPr/>
          </p:nvSpPr>
          <p:spPr>
            <a:xfrm rot="16200000">
              <a:off x="447215" y="4703520"/>
              <a:ext cx="32573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50" i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wt</a:t>
              </a:r>
              <a:endParaRPr lang="en-US" sz="1050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0" name="TextBox 69"/>
            <p:cNvSpPr txBox="1"/>
            <p:nvPr/>
          </p:nvSpPr>
          <p:spPr>
            <a:xfrm rot="16200000">
              <a:off x="1059519" y="4703520"/>
              <a:ext cx="32573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50" i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wt</a:t>
              </a:r>
              <a:endParaRPr lang="en-US" sz="1050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1" name="TextBox 70"/>
            <p:cNvSpPr txBox="1"/>
            <p:nvPr/>
          </p:nvSpPr>
          <p:spPr>
            <a:xfrm rot="16200000">
              <a:off x="2544285" y="4703520"/>
              <a:ext cx="32573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50" i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wt</a:t>
              </a:r>
              <a:endParaRPr lang="en-US" sz="1050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6" name="TextBox 75"/>
            <p:cNvSpPr txBox="1"/>
            <p:nvPr/>
          </p:nvSpPr>
          <p:spPr>
            <a:xfrm rot="16200000">
              <a:off x="618015" y="4573676"/>
              <a:ext cx="585417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50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bo1</a:t>
              </a:r>
              <a:r>
                <a:rPr lang="en-US" sz="105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∆</a:t>
              </a:r>
              <a:endParaRPr lang="en-US" sz="10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7" name="TextBox 76"/>
            <p:cNvSpPr txBox="1"/>
            <p:nvPr/>
          </p:nvSpPr>
          <p:spPr>
            <a:xfrm rot="16200000">
              <a:off x="1214477" y="4573676"/>
              <a:ext cx="585417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50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bo1</a:t>
              </a:r>
              <a:r>
                <a:rPr lang="en-US" sz="105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∆</a:t>
              </a:r>
              <a:endParaRPr lang="en-US" sz="10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8" name="TextBox 77"/>
            <p:cNvSpPr txBox="1"/>
            <p:nvPr/>
          </p:nvSpPr>
          <p:spPr>
            <a:xfrm rot="16200000">
              <a:off x="2109401" y="4573676"/>
              <a:ext cx="585417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50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bo1</a:t>
              </a:r>
              <a:r>
                <a:rPr lang="en-US" sz="105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∆</a:t>
              </a:r>
              <a:endParaRPr lang="en-US" sz="10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9" name="TextBox 78"/>
            <p:cNvSpPr txBox="1"/>
            <p:nvPr/>
          </p:nvSpPr>
          <p:spPr>
            <a:xfrm rot="16200000">
              <a:off x="2740531" y="4573676"/>
              <a:ext cx="585417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50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bo1</a:t>
              </a:r>
              <a:r>
                <a:rPr lang="en-US" sz="105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∆</a:t>
              </a:r>
              <a:endParaRPr lang="en-US" sz="10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18" name="Group 117"/>
          <p:cNvGrpSpPr/>
          <p:nvPr/>
        </p:nvGrpSpPr>
        <p:grpSpPr>
          <a:xfrm>
            <a:off x="734199" y="4868198"/>
            <a:ext cx="2555896" cy="0"/>
            <a:chOff x="543699" y="4868198"/>
            <a:chExt cx="2555896" cy="0"/>
          </a:xfrm>
        </p:grpSpPr>
        <p:cxnSp>
          <p:nvCxnSpPr>
            <p:cNvPr id="84" name="Straight Connector 83"/>
            <p:cNvCxnSpPr/>
            <p:nvPr/>
          </p:nvCxnSpPr>
          <p:spPr>
            <a:xfrm>
              <a:off x="543699" y="4868198"/>
              <a:ext cx="40441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5" name="Straight Connector 84"/>
            <p:cNvCxnSpPr/>
            <p:nvPr/>
          </p:nvCxnSpPr>
          <p:spPr>
            <a:xfrm>
              <a:off x="1174175" y="4868198"/>
              <a:ext cx="40441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6" name="Straight Connector 85"/>
            <p:cNvCxnSpPr/>
            <p:nvPr/>
          </p:nvCxnSpPr>
          <p:spPr>
            <a:xfrm>
              <a:off x="2048378" y="4868198"/>
              <a:ext cx="40441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7" name="Straight Connector 86"/>
            <p:cNvCxnSpPr/>
            <p:nvPr/>
          </p:nvCxnSpPr>
          <p:spPr>
            <a:xfrm>
              <a:off x="2695185" y="4868198"/>
              <a:ext cx="40441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09" name="Group 108"/>
          <p:cNvGrpSpPr/>
          <p:nvPr/>
        </p:nvGrpSpPr>
        <p:grpSpPr>
          <a:xfrm>
            <a:off x="3958732" y="4395770"/>
            <a:ext cx="2684770" cy="585418"/>
            <a:chOff x="479275" y="4411772"/>
            <a:chExt cx="2684770" cy="585418"/>
          </a:xfrm>
        </p:grpSpPr>
        <p:sp>
          <p:nvSpPr>
            <p:cNvPr id="110" name="TextBox 109"/>
            <p:cNvSpPr txBox="1"/>
            <p:nvPr/>
          </p:nvSpPr>
          <p:spPr>
            <a:xfrm rot="16200000">
              <a:off x="1956913" y="4703520"/>
              <a:ext cx="32573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50" i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wt</a:t>
              </a:r>
              <a:endParaRPr lang="en-US" sz="1050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1" name="TextBox 110"/>
            <p:cNvSpPr txBox="1"/>
            <p:nvPr/>
          </p:nvSpPr>
          <p:spPr>
            <a:xfrm rot="16200000">
              <a:off x="447215" y="4703520"/>
              <a:ext cx="32573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50" i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wt</a:t>
              </a:r>
              <a:endParaRPr lang="en-US" sz="1050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2" name="TextBox 111"/>
            <p:cNvSpPr txBox="1"/>
            <p:nvPr/>
          </p:nvSpPr>
          <p:spPr>
            <a:xfrm rot="16200000">
              <a:off x="1059519" y="4703520"/>
              <a:ext cx="32573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50" i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wt</a:t>
              </a:r>
              <a:endParaRPr lang="en-US" sz="1050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3" name="TextBox 112"/>
            <p:cNvSpPr txBox="1"/>
            <p:nvPr/>
          </p:nvSpPr>
          <p:spPr>
            <a:xfrm rot="16200000">
              <a:off x="2544285" y="4703520"/>
              <a:ext cx="32573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50" i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wt</a:t>
              </a:r>
              <a:endParaRPr lang="en-US" sz="1050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4" name="TextBox 113"/>
            <p:cNvSpPr txBox="1"/>
            <p:nvPr/>
          </p:nvSpPr>
          <p:spPr>
            <a:xfrm rot="16200000">
              <a:off x="618015" y="4573676"/>
              <a:ext cx="585417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50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bo1</a:t>
              </a:r>
              <a:r>
                <a:rPr lang="en-US" sz="105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∆</a:t>
              </a:r>
              <a:endParaRPr lang="en-US" sz="10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5" name="TextBox 114"/>
            <p:cNvSpPr txBox="1"/>
            <p:nvPr/>
          </p:nvSpPr>
          <p:spPr>
            <a:xfrm rot="16200000">
              <a:off x="1214477" y="4573676"/>
              <a:ext cx="585417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50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bo1</a:t>
              </a:r>
              <a:r>
                <a:rPr lang="en-US" sz="105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∆</a:t>
              </a:r>
              <a:endParaRPr lang="en-US" sz="10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6" name="TextBox 115"/>
            <p:cNvSpPr txBox="1"/>
            <p:nvPr/>
          </p:nvSpPr>
          <p:spPr>
            <a:xfrm rot="16200000">
              <a:off x="2109401" y="4573676"/>
              <a:ext cx="585417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50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bo1</a:t>
              </a:r>
              <a:r>
                <a:rPr lang="en-US" sz="105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∆</a:t>
              </a:r>
              <a:endParaRPr lang="en-US" sz="10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7" name="TextBox 116"/>
            <p:cNvSpPr txBox="1"/>
            <p:nvPr/>
          </p:nvSpPr>
          <p:spPr>
            <a:xfrm rot="16200000">
              <a:off x="2740531" y="4573676"/>
              <a:ext cx="585417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50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bo1</a:t>
              </a:r>
              <a:r>
                <a:rPr lang="en-US" sz="105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∆</a:t>
              </a:r>
              <a:endParaRPr lang="en-US" sz="10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19" name="Group 118"/>
          <p:cNvGrpSpPr/>
          <p:nvPr/>
        </p:nvGrpSpPr>
        <p:grpSpPr>
          <a:xfrm>
            <a:off x="4045821" y="4933563"/>
            <a:ext cx="2555896" cy="0"/>
            <a:chOff x="543699" y="4868198"/>
            <a:chExt cx="2555896" cy="0"/>
          </a:xfrm>
        </p:grpSpPr>
        <p:cxnSp>
          <p:nvCxnSpPr>
            <p:cNvPr id="120" name="Straight Connector 119"/>
            <p:cNvCxnSpPr/>
            <p:nvPr/>
          </p:nvCxnSpPr>
          <p:spPr>
            <a:xfrm>
              <a:off x="543699" y="4868198"/>
              <a:ext cx="40441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1" name="Straight Connector 120"/>
            <p:cNvCxnSpPr/>
            <p:nvPr/>
          </p:nvCxnSpPr>
          <p:spPr>
            <a:xfrm>
              <a:off x="1174175" y="4868198"/>
              <a:ext cx="40441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2" name="Straight Connector 121"/>
            <p:cNvCxnSpPr/>
            <p:nvPr/>
          </p:nvCxnSpPr>
          <p:spPr>
            <a:xfrm>
              <a:off x="2048378" y="4868198"/>
              <a:ext cx="40441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3" name="Straight Connector 122"/>
            <p:cNvCxnSpPr/>
            <p:nvPr/>
          </p:nvCxnSpPr>
          <p:spPr>
            <a:xfrm>
              <a:off x="2695185" y="4868198"/>
              <a:ext cx="40441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24" name="TextBox 123"/>
          <p:cNvSpPr txBox="1"/>
          <p:nvPr/>
        </p:nvSpPr>
        <p:spPr>
          <a:xfrm>
            <a:off x="-88290" y="5159719"/>
            <a:ext cx="5709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~55 </a:t>
            </a:r>
            <a:r>
              <a:rPr lang="en-GB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5" name="TextBox 124"/>
          <p:cNvSpPr txBox="1"/>
          <p:nvPr/>
        </p:nvSpPr>
        <p:spPr>
          <a:xfrm>
            <a:off x="-88893" y="5974686"/>
            <a:ext cx="5709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~15 </a:t>
            </a:r>
            <a:r>
              <a:rPr lang="en-GB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6" name="TextBox 125"/>
          <p:cNvSpPr txBox="1"/>
          <p:nvPr/>
        </p:nvSpPr>
        <p:spPr>
          <a:xfrm>
            <a:off x="3300971" y="5198022"/>
            <a:ext cx="5709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~55 </a:t>
            </a:r>
            <a:r>
              <a:rPr lang="en-GB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7" name="TextBox 126"/>
          <p:cNvSpPr txBox="1"/>
          <p:nvPr/>
        </p:nvSpPr>
        <p:spPr>
          <a:xfrm>
            <a:off x="3271793" y="6012989"/>
            <a:ext cx="5709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~15 </a:t>
            </a:r>
            <a:r>
              <a:rPr lang="en-GB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29</TotalTime>
  <Words>81</Words>
  <Application>Microsoft Office PowerPoint</Application>
  <PresentationFormat>On-screen Show (4:3)</PresentationFormat>
  <Paragraphs>45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Company>Newcastle University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nskw</dc:creator>
  <cp:lastModifiedBy>Simon Whitehall</cp:lastModifiedBy>
  <cp:revision>62</cp:revision>
  <dcterms:created xsi:type="dcterms:W3CDTF">2013-05-16T09:04:23Z</dcterms:created>
  <dcterms:modified xsi:type="dcterms:W3CDTF">2015-09-15T09:54:22Z</dcterms:modified>
</cp:coreProperties>
</file>